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483" r:id="rId2"/>
    <p:sldId id="477" r:id="rId3"/>
    <p:sldId id="478" r:id="rId4"/>
    <p:sldId id="480" r:id="rId5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775DCB02-9BB8-47FD-8907-85C794F793BA}" styleName="Themed Style 1 - Accent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058" autoAdjust="0"/>
  </p:normalViewPr>
  <p:slideViewPr>
    <p:cSldViewPr>
      <p:cViewPr>
        <p:scale>
          <a:sx n="80" d="100"/>
          <a:sy n="80" d="100"/>
        </p:scale>
        <p:origin x="-1410" y="-1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>
      <p:cViewPr varScale="1">
        <p:scale>
          <a:sx n="79" d="100"/>
          <a:sy n="79" d="100"/>
        </p:scale>
        <p:origin x="-1980" y="-90"/>
      </p:cViewPr>
      <p:guideLst>
        <p:guide orient="horz" pos="2928"/>
        <p:guide pos="2208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7413" cy="464180"/>
          </a:xfrm>
          <a:prstGeom prst="rect">
            <a:avLst/>
          </a:prstGeom>
        </p:spPr>
        <p:txBody>
          <a:bodyPr vert="horz" lIns="92222" tIns="46111" rIns="92222" bIns="46111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30622"/>
            <a:ext cx="3037413" cy="464180"/>
          </a:xfrm>
          <a:prstGeom prst="rect">
            <a:avLst/>
          </a:prstGeom>
        </p:spPr>
        <p:txBody>
          <a:bodyPr vert="horz" lIns="92222" tIns="46111" rIns="92222" bIns="46111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1386" y="8830622"/>
            <a:ext cx="3037413" cy="464180"/>
          </a:xfrm>
          <a:prstGeom prst="rect">
            <a:avLst/>
          </a:prstGeom>
        </p:spPr>
        <p:txBody>
          <a:bodyPr vert="horz" lIns="92222" tIns="46111" rIns="92222" bIns="46111" rtlCol="0" anchor="b"/>
          <a:lstStyle>
            <a:lvl1pPr algn="r">
              <a:defRPr sz="1200"/>
            </a:lvl1pPr>
          </a:lstStyle>
          <a:p>
            <a:fld id="{6C677157-F274-4768-A3AF-F5847826ACF7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783246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1" tIns="46586" rIns="93171" bIns="46586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1" tIns="46586" rIns="93171" bIns="46586" rtlCol="0"/>
          <a:lstStyle>
            <a:lvl1pPr algn="r">
              <a:defRPr sz="1200"/>
            </a:lvl1pPr>
          </a:lstStyle>
          <a:p>
            <a:fld id="{DAA326DA-C90F-477B-AF20-F1D40BEAB29B}" type="datetimeFigureOut">
              <a:rPr lang="en-US" smtClean="0"/>
              <a:pPr/>
              <a:t>4/13/2020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8500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1" tIns="46586" rIns="93171" bIns="46586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1" tIns="46586" rIns="93171" bIns="46586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1" tIns="46586" rIns="93171" bIns="46586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1" tIns="46586" rIns="93171" bIns="46586" rtlCol="0" anchor="b"/>
          <a:lstStyle>
            <a:lvl1pPr algn="r">
              <a:defRPr sz="1200"/>
            </a:lvl1pPr>
          </a:lstStyle>
          <a:p>
            <a:fld id="{BCE7A8B5-E623-498C-A174-94FF5308EB16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96685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B2F108-7A76-42D7-B5B7-B38D138619E3}" type="datetime1">
              <a:rPr lang="en-US" smtClean="0"/>
              <a:pPr/>
              <a:t>4/13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3C08F-FF93-4A1E-8DDD-48DC386FEC1E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8117886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21474D-E7CB-44E3-AC1E-15706BE51C50}" type="datetime1">
              <a:rPr lang="en-US" smtClean="0"/>
              <a:pPr/>
              <a:t>4/13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3C08F-FF93-4A1E-8DDD-48DC386FEC1E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7015342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56C2-6958-43AD-B044-8987EDC887CE}" type="datetime1">
              <a:rPr lang="en-US" smtClean="0"/>
              <a:pPr/>
              <a:t>4/13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3C08F-FF93-4A1E-8DDD-48DC386FEC1E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0072272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FFD31-CD5E-44BE-8111-A07DA3FBD437}" type="datetime1">
              <a:rPr lang="en-US" smtClean="0"/>
              <a:pPr/>
              <a:t>4/13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3C08F-FF93-4A1E-8DDD-48DC386FEC1E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6687568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011C4-169C-47BB-B22B-3131166B308E}" type="datetime1">
              <a:rPr lang="en-US" smtClean="0"/>
              <a:pPr/>
              <a:t>4/13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3C08F-FF93-4A1E-8DDD-48DC386FEC1E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3111939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75E5E-4763-46E5-BD80-B6287502E758}" type="datetime1">
              <a:rPr lang="en-US" smtClean="0"/>
              <a:pPr/>
              <a:t>4/13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3C08F-FF93-4A1E-8DDD-48DC386FEC1E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4560940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5925A4-A473-4D2E-BFA0-A6F62AC4A2A0}" type="datetime1">
              <a:rPr lang="en-US" smtClean="0"/>
              <a:pPr/>
              <a:t>4/13/20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3C08F-FF93-4A1E-8DDD-48DC386FEC1E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15325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0DFBD0-D73E-4525-BFD1-22A524D39CB7}" type="datetime1">
              <a:rPr lang="en-US" smtClean="0"/>
              <a:pPr/>
              <a:t>4/13/20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3C08F-FF93-4A1E-8DDD-48DC386FEC1E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196930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C59F5-2FBD-4E0C-B74F-2F24F8FB5D1D}" type="datetime1">
              <a:rPr lang="en-US" smtClean="0"/>
              <a:pPr/>
              <a:t>4/13/20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3C08F-FF93-4A1E-8DDD-48DC386FEC1E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221115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E308B-5B07-4746-A0FF-EB400FF19152}" type="datetime1">
              <a:rPr lang="en-US" smtClean="0"/>
              <a:pPr/>
              <a:t>4/13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3C08F-FF93-4A1E-8DDD-48DC386FEC1E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255749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70C884-0121-4681-B22A-460F44F01A47}" type="datetime1">
              <a:rPr lang="en-US" smtClean="0"/>
              <a:pPr/>
              <a:t>4/13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3C08F-FF93-4A1E-8DDD-48DC386FEC1E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8886473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E82F34-EA76-45AC-AB8B-A72580717C7A}" type="datetime1">
              <a:rPr lang="en-US" smtClean="0"/>
              <a:pPr/>
              <a:t>4/13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53C08F-FF93-4A1E-8DDD-48DC386FEC1E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8977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  <p:hf hdr="0" ftr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tif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TSPAN5 influences serotonin and kynurenine: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harmacogenomic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mechanisms related to alcohol use disorder and acamprosate treatment response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ing-Fen Ho, Ph.D.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Cheng Zhang, Ph.D.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Lingxin Zhang, Ph.D.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Lixuan Wei, M.D. Ph.D.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Ying Zhou, Ph.D.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Irene Moon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Jennifer R. Geske, M.S.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Doo-Sup Choi, Ph.D.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Joanna Biernacka, Ph.D.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Mark Frye,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.D.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hexing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n, Ph.D.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ictor M Karpyak, M.D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., 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Ph.D.</a:t>
            </a:r>
            <a:r>
              <a:rPr lang="en-US" sz="1200" baseline="3000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u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i, Ph.D.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nd Richard Weinshilboum, M.D.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Time course analysis of 5-HT concentrations in SK-N-BE2 cell culture medium in response to EtOH treatment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Dose response curve of 5-HT concentrations in SK-N-BE2 cell culture medium in response to acamprosate treatment. </a:t>
            </a:r>
          </a:p>
          <a:p>
            <a:pPr marL="0" indent="0">
              <a:buNone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PSC generation, culture and characterization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chematic diagram depicting the timeline of glial and neuronal cell differentiation processes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Immunofluorescence staining of iPSC lines, astrocytes and neurons.   </a:t>
            </a:r>
          </a:p>
          <a:p>
            <a:pPr marL="0" indent="0">
              <a:buNone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SPAN5 function in HMC3 cells.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(a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ower ISRE luciferase activities were observed in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SPAN5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knockout cells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Knockdown of TSPAN5 resulted in the downregulation of a series of genes involved in interferon signaling, compatible with the data shown in panels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hen cells were exposed to either EtOH or acamprosate. 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C59F5-2FBD-4E0C-B74F-2F24F8FB5D1D}" type="datetime1">
              <a:rPr lang="en-US" smtClean="0"/>
              <a:pPr/>
              <a:t>4/13/2020</a:t>
            </a:fld>
            <a:endParaRPr lang="en-US" dirty="0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3C08F-FF93-4A1E-8DDD-48DC386FEC1E}" type="slidenum">
              <a:rPr lang="en-US" smtClean="0"/>
              <a:pPr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7648196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0549" y="0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081"/>
          <a:stretch/>
        </p:blipFill>
        <p:spPr bwMode="auto">
          <a:xfrm>
            <a:off x="3200400" y="1012195"/>
            <a:ext cx="3079750" cy="21346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3C08F-FF93-4A1E-8DDD-48DC386FEC1E}" type="slidenum">
              <a:rPr lang="en-US" smtClean="0"/>
              <a:pPr/>
              <a:t>2</a:t>
            </a:fld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304800" y="759023"/>
            <a:ext cx="32544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                                                                        b</a:t>
            </a:r>
            <a:endParaRPr lang="en-US" sz="1400" b="1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445"/>
          <a:stretch/>
        </p:blipFill>
        <p:spPr bwMode="auto">
          <a:xfrm>
            <a:off x="391319" y="1066800"/>
            <a:ext cx="2674937" cy="21208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404459" y="881390"/>
            <a:ext cx="8467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SK-N-BE (2)</a:t>
            </a:r>
            <a:endParaRPr lang="en-US" sz="11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4572000" y="894255"/>
            <a:ext cx="8467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SK-N-BE (2)</a:t>
            </a:r>
            <a:endParaRPr 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401207500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549" y="0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26"/>
          <a:stretch/>
        </p:blipFill>
        <p:spPr bwMode="auto">
          <a:xfrm>
            <a:off x="3498459" y="2629224"/>
            <a:ext cx="1328135" cy="14469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3059" y="2629224"/>
            <a:ext cx="1336248" cy="1445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724544" y="1990129"/>
            <a:ext cx="3759747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sz="1400" b="1" dirty="0" smtClean="0"/>
              <a:t>   iPSC                          astrocytes                neurons</a:t>
            </a:r>
            <a:endParaRPr lang="en-US" sz="1400" b="1" dirty="0"/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0305" y="2629224"/>
            <a:ext cx="1373903" cy="14469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12"/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414" r="30451"/>
          <a:stretch/>
        </p:blipFill>
        <p:spPr bwMode="auto">
          <a:xfrm>
            <a:off x="724544" y="1066799"/>
            <a:ext cx="4901609" cy="8127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4" name="TextBox 13"/>
          <p:cNvSpPr txBox="1"/>
          <p:nvPr/>
        </p:nvSpPr>
        <p:spPr>
          <a:xfrm>
            <a:off x="838200" y="2398276"/>
            <a:ext cx="14638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00B050"/>
                </a:solidFill>
              </a:rPr>
              <a:t>SOX2</a:t>
            </a:r>
            <a:r>
              <a:rPr lang="en-US" sz="1000" b="1" dirty="0" smtClean="0">
                <a:solidFill>
                  <a:srgbClr val="FF0000"/>
                </a:solidFill>
              </a:rPr>
              <a:t>/TRA-1-81/</a:t>
            </a:r>
            <a:r>
              <a:rPr lang="en-US" sz="1000" b="1" dirty="0" smtClean="0">
                <a:solidFill>
                  <a:srgbClr val="0070C0"/>
                </a:solidFill>
              </a:rPr>
              <a:t>DAPI</a:t>
            </a:r>
            <a:endParaRPr lang="en-US" sz="1000" b="1" dirty="0">
              <a:solidFill>
                <a:srgbClr val="0070C0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178008" y="2398276"/>
            <a:ext cx="12442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00B050"/>
                </a:solidFill>
              </a:rPr>
              <a:t>GFAP</a:t>
            </a:r>
            <a:r>
              <a:rPr lang="en-US" sz="1000" b="1" dirty="0" smtClean="0">
                <a:solidFill>
                  <a:srgbClr val="FF0000"/>
                </a:solidFill>
              </a:rPr>
              <a:t>/CD44/</a:t>
            </a:r>
            <a:r>
              <a:rPr lang="en-US" sz="1000" b="1" dirty="0" smtClean="0">
                <a:solidFill>
                  <a:srgbClr val="0070C0"/>
                </a:solidFill>
              </a:rPr>
              <a:t>DAPI</a:t>
            </a:r>
            <a:endParaRPr lang="en-US" sz="1000" b="1" dirty="0">
              <a:solidFill>
                <a:srgbClr val="0070C0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650859" y="4150876"/>
            <a:ext cx="1204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00B050"/>
                </a:solidFill>
              </a:rPr>
              <a:t>FOXG1</a:t>
            </a:r>
            <a:r>
              <a:rPr lang="en-US" sz="1000" b="1" dirty="0" smtClean="0">
                <a:solidFill>
                  <a:srgbClr val="FF0000"/>
                </a:solidFill>
              </a:rPr>
              <a:t>/GFAP/</a:t>
            </a:r>
            <a:r>
              <a:rPr lang="en-US" sz="1000" b="1" dirty="0" smtClean="0">
                <a:solidFill>
                  <a:srgbClr val="0070C0"/>
                </a:solidFill>
              </a:rPr>
              <a:t>DAPI</a:t>
            </a:r>
            <a:endParaRPr lang="en-US" sz="1000" b="1" dirty="0">
              <a:solidFill>
                <a:srgbClr val="0070C0"/>
              </a:solidFill>
            </a:endParaRPr>
          </a:p>
        </p:txBody>
      </p:sp>
      <p:pic>
        <p:nvPicPr>
          <p:cNvPr id="18" name="Picture 2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46"/>
          <a:stretch/>
        </p:blipFill>
        <p:spPr bwMode="auto">
          <a:xfrm>
            <a:off x="2203060" y="4368102"/>
            <a:ext cx="1336248" cy="13840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" name="TextBox 18"/>
          <p:cNvSpPr txBox="1"/>
          <p:nvPr/>
        </p:nvSpPr>
        <p:spPr>
          <a:xfrm>
            <a:off x="2203059" y="4150876"/>
            <a:ext cx="1236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chemeClr val="accent1"/>
                </a:solidFill>
              </a:rPr>
              <a:t>DAPI</a:t>
            </a:r>
            <a:r>
              <a:rPr lang="en-US" sz="1000" b="1" dirty="0" smtClean="0"/>
              <a:t> </a:t>
            </a:r>
            <a:r>
              <a:rPr lang="en-US" sz="1000" b="1" dirty="0" smtClean="0">
                <a:solidFill>
                  <a:srgbClr val="00B050"/>
                </a:solidFill>
              </a:rPr>
              <a:t>/S100B</a:t>
            </a:r>
            <a:r>
              <a:rPr lang="en-US" sz="1000" b="1" dirty="0" smtClean="0">
                <a:solidFill>
                  <a:srgbClr val="FF0000"/>
                </a:solidFill>
              </a:rPr>
              <a:t>/MAP2</a:t>
            </a:r>
            <a:endParaRPr lang="en-US" sz="1000" b="1" dirty="0">
              <a:solidFill>
                <a:srgbClr val="FF0000"/>
              </a:solidFill>
            </a:endParaRPr>
          </a:p>
        </p:txBody>
      </p:sp>
      <p:sp>
        <p:nvSpPr>
          <p:cNvPr id="20" name="Slide Number Placeholder 19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3C08F-FF93-4A1E-8DDD-48DC386FEC1E}" type="slidenum">
              <a:rPr lang="en-US" smtClean="0"/>
              <a:pPr/>
              <a:t>3</a:t>
            </a:fld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304800" y="759023"/>
            <a:ext cx="1875835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                                        </a:t>
            </a:r>
          </a:p>
          <a:p>
            <a:endParaRPr lang="en-US" sz="1400" b="1" dirty="0"/>
          </a:p>
          <a:p>
            <a:endParaRPr lang="en-US" sz="1400" b="1" dirty="0" smtClean="0"/>
          </a:p>
          <a:p>
            <a:endParaRPr lang="en-US" sz="1400" b="1" dirty="0"/>
          </a:p>
          <a:p>
            <a:endParaRPr lang="en-US" sz="1400" b="1" dirty="0" smtClean="0"/>
          </a:p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838200" y="4150876"/>
            <a:ext cx="14638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00B050"/>
                </a:solidFill>
              </a:rPr>
              <a:t>SOX2</a:t>
            </a:r>
            <a:r>
              <a:rPr lang="en-US" sz="1000" b="1" dirty="0" smtClean="0">
                <a:solidFill>
                  <a:srgbClr val="FF0000"/>
                </a:solidFill>
              </a:rPr>
              <a:t>/TRA-1-81/</a:t>
            </a:r>
            <a:r>
              <a:rPr lang="en-US" sz="1000" b="1" dirty="0" smtClean="0">
                <a:solidFill>
                  <a:srgbClr val="0070C0"/>
                </a:solidFill>
              </a:rPr>
              <a:t>DAPI</a:t>
            </a:r>
            <a:endParaRPr lang="en-US" sz="1000" b="1" dirty="0">
              <a:solidFill>
                <a:srgbClr val="0070C0"/>
              </a:solidFill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727059" y="2398276"/>
            <a:ext cx="12731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00B050"/>
                </a:solidFill>
              </a:rPr>
              <a:t>MAP2</a:t>
            </a:r>
            <a:r>
              <a:rPr lang="en-US" sz="1000" b="1" dirty="0" smtClean="0">
                <a:solidFill>
                  <a:srgbClr val="FF0000"/>
                </a:solidFill>
              </a:rPr>
              <a:t>/GFAP/</a:t>
            </a:r>
            <a:r>
              <a:rPr lang="en-US" sz="1000" b="1" dirty="0" smtClean="0">
                <a:solidFill>
                  <a:srgbClr val="0070C0"/>
                </a:solidFill>
              </a:rPr>
              <a:t>DAPI</a:t>
            </a:r>
            <a:endParaRPr lang="en-US" sz="1000" b="1" dirty="0">
              <a:solidFill>
                <a:srgbClr val="0070C0"/>
              </a:solidFill>
            </a:endParaRPr>
          </a:p>
        </p:txBody>
      </p:sp>
      <p:pic>
        <p:nvPicPr>
          <p:cNvPr id="1026" name="Picture 2" descr="H:\Lab work\AUD\AUD MS1\tujM_FOG1R_3.tif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695"/>
          <a:stretch/>
        </p:blipFill>
        <p:spPr bwMode="auto">
          <a:xfrm>
            <a:off x="3498459" y="4368102"/>
            <a:ext cx="1328134" cy="13840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3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390" t="25012" r="6088" b="22783"/>
          <a:stretch/>
        </p:blipFill>
        <p:spPr bwMode="auto">
          <a:xfrm>
            <a:off x="880305" y="4368102"/>
            <a:ext cx="1373903" cy="13840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26376702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4600" y="873075"/>
            <a:ext cx="3944354" cy="22858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0550" y="0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7200" y="3276600"/>
            <a:ext cx="5334000" cy="2719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9810" y="6019800"/>
            <a:ext cx="5817185" cy="27198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53C08F-FF93-4A1E-8DDD-48DC386FEC1E}" type="slidenum">
              <a:rPr lang="en-US" smtClean="0"/>
              <a:pPr/>
              <a:t>4</a:t>
            </a:fld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04800" y="533400"/>
            <a:ext cx="21323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                                            b</a:t>
            </a:r>
            <a:endParaRPr lang="en-US" sz="1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28600" y="3111613"/>
            <a:ext cx="279244" cy="31085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  <a:endParaRPr lang="en-US" sz="1400" b="1" dirty="0" smtClean="0"/>
          </a:p>
          <a:p>
            <a:endParaRPr lang="en-US" sz="1400" b="1" dirty="0"/>
          </a:p>
          <a:p>
            <a:endParaRPr lang="en-US" sz="1400" b="1" dirty="0" smtClean="0"/>
          </a:p>
          <a:p>
            <a:endParaRPr lang="en-US" sz="1400" b="1" dirty="0"/>
          </a:p>
          <a:p>
            <a:endParaRPr lang="en-US" sz="1400" b="1" dirty="0" smtClean="0"/>
          </a:p>
          <a:p>
            <a:endParaRPr lang="en-US" sz="1400" b="1" dirty="0"/>
          </a:p>
          <a:p>
            <a:endParaRPr lang="en-US" sz="1400" b="1" dirty="0" smtClean="0"/>
          </a:p>
          <a:p>
            <a:endParaRPr lang="en-US" sz="1400" b="1" dirty="0"/>
          </a:p>
          <a:p>
            <a:endParaRPr lang="en-US" sz="1400" b="1" dirty="0" smtClean="0"/>
          </a:p>
          <a:p>
            <a:endParaRPr lang="en-US" sz="1400" b="1" dirty="0"/>
          </a:p>
          <a:p>
            <a:endParaRPr lang="en-US" sz="1400" b="1" dirty="0" smtClean="0"/>
          </a:p>
          <a:p>
            <a:endParaRPr lang="en-US" sz="1400" b="1" dirty="0"/>
          </a:p>
          <a:p>
            <a:endParaRPr lang="en-US" sz="1400" b="1" dirty="0" smtClean="0"/>
          </a:p>
          <a:p>
            <a:r>
              <a:rPr lang="en-US" sz="1400" b="1" dirty="0"/>
              <a:t>d</a:t>
            </a:r>
          </a:p>
        </p:txBody>
      </p:sp>
      <p:pic>
        <p:nvPicPr>
          <p:cNvPr id="15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7844" y="703237"/>
            <a:ext cx="1794533" cy="2743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1557477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50">
        <p:fade/>
      </p:transition>
    </mc:Choice>
    <mc:Fallback xmlns="">
      <p:transition>
        <p:fade/>
      </p:transition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3</Words>
  <Application>Microsoft Office PowerPoint</Application>
  <PresentationFormat>On-screen Show (4:3)</PresentationFormat>
  <Paragraphs>45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TSPAN5 influences serotonin and kynurenine: pharmacogenomic mechanisms related to alcohol use disorder and acamprosate treatment response   Ming-Fen Ho, Ph.D.1, Cheng Zhang, Ph.D.1, Lingxin Zhang, Ph.D.1, Lixuan Wei, M.D. Ph.D.1, Ying Zhou, Ph.D.2, Irene Moon1, Jennifer R. Geske, M.S.3, Doo-Sup Choi, Ph.D.1, Joanna Biernacka, Ph.D.3, Mark Frye, M.D.4, Zhexing Wen, Ph.D.2, Victor M Karpyak, M.D., Ph.D.4, Hu Li, Ph.D.1, and Richard Weinshilboum, M.D.1.* 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created xsi:type="dcterms:W3CDTF">2016-04-07T16:00:49Z</dcterms:created>
  <dcterms:modified xsi:type="dcterms:W3CDTF">2020-04-13T18:15:17Z</dcterms:modified>
</cp:coreProperties>
</file>